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1" r:id="rId2"/>
    <p:sldId id="264" r:id="rId3"/>
    <p:sldId id="265" r:id="rId4"/>
    <p:sldId id="266" r:id="rId5"/>
    <p:sldId id="267" r:id="rId6"/>
    <p:sldId id="26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98" d="100"/>
          <a:sy n="98" d="100"/>
        </p:scale>
        <p:origin x="532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A9A690-05FB-4D73-B202-76079FBD1680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CE4C68-88D9-44A8-9F4B-A3A544AC9C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9190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E06309-3784-4163-A712-80EEA1B7F577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3917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E06309-3784-4163-A712-80EEA1B7F577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01269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8580E8-64C2-B6D6-2579-C464E76812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9CF961-5715-0CC0-70FB-46EF683928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6CCBDD-E8A9-CB9A-BD6E-6564446FF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40B799-AEC3-41A1-F605-3F2EC94E3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BA9D7-02AC-465D-69D7-B2552B376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9797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05490-CE9C-EAB9-0B83-2D5DD7942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6B8036-AE41-F306-2029-1936EC15E7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E75803-22B9-51F3-94EC-8026C9946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4BADE1-9D2C-12B2-07C0-EF1D82A51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F32EAA-26D4-81FF-29FC-F4D724A42F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8311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F689C1-BB6A-3C92-C4E4-A0A2E9F929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002AC7F-FD0F-CFFA-525E-0261727505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82A740-0DE9-2816-D945-826E3741A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960E06-3C32-DD79-90C9-51C8819D45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9E1AFF-F993-FE6D-5D18-7ACEDE7037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4924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48C55A-2F28-7EA7-9BDD-ACF573628F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F74631-0D10-55B8-8BEA-09D99E2198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0ADA78-D644-2D72-57A1-548B83BB9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592010-774A-2280-C76F-C58CB8EB5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5D990E-0183-5C52-5CD6-045E0E9883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4880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84E44D-772F-7BD5-4200-E5330722E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66441B-3981-DA24-3B12-3C37CA6AB7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419F38-BCE3-7352-E63B-624606E44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70841-2DFF-8FB8-D519-112C2A989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A85A1C-5EB5-A0F7-20AB-949E59139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4837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B811D-2CCB-CDDE-1D19-631CBEC57F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EDC53E-2D96-57E8-EE43-1F1C8A5359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E05C2B-7FFA-0080-4FAE-85488317E2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1E1AF3-628E-C6BE-F6F8-9AA87A75F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6DC4A9-B839-C424-4944-96ABC6C28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ADE4B5-DF04-3207-EC59-128012572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2467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992D80-A511-AB2A-34A8-4EE9CEE49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FCF00E-DEE2-EC86-1494-E21AD9354A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B97206-C0B5-F816-6419-68C22C5E32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D3FFBA7-F107-B072-4C40-A3FC4D39B4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DEB2B1-0D4B-79F8-F12A-2132405AD4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8CBF4F-B3E2-A4E5-C491-01A3E7F60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AAA7AC-FE75-EC46-0B4C-B9F3BD754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FA8C4F-81AE-21D4-DB67-32F1B9140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47408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5EC3F5-2A5D-468F-07FD-076277BFC6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A37326-6B05-6752-0D02-2F074F2E3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D6CEF52-69DD-1A3F-B567-6B87DF9DB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60457B-6CF9-7CBE-2A27-209426D5E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2258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F1E17C-1612-D76D-046F-5AA663EBB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810C8F-CA6A-EA0E-6E6F-9DF2054DB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30359A7-02F3-445D-164B-4D1575F6C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1788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E3F8FC-EE77-41EA-EDE5-8C311DEB47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5E8C57-07B7-C21E-6E31-887B2687D7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107C3B-764A-F0DF-864C-64BF9B7C70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0A362F-86DC-8FD2-F9F3-ABBB6DBA4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A8E54F-97B3-13B6-BA77-25CBB1A0C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E85E57-5AF4-2169-FCAE-72E57B2AB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1502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1EC819-99FC-36D9-E6DA-AEEBE6EC75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CF22B1-6D83-C59C-1C15-37399208F5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284F91-190C-4F92-580D-75FC99E483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D1F80C-6641-3297-10C0-5E25ADD93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F1827F-95D8-CD13-370A-BE11F2886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702E1E-F015-DF5F-CB45-9F1688C3B1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4997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48BA66-53C1-9A7F-1054-5C6E1BE7CF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5D206A-A7CE-4390-F82D-95C3707492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DA8508-194B-06CA-BB06-4B03947E55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D3652E-6D72-4783-A0BC-153F076D8689}" type="datetimeFigureOut">
              <a:rPr lang="en-GB" smtClean="0"/>
              <a:t>06/05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5ACE98-9807-1276-7867-09F2F09C56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88F28F-79D6-BA59-7862-D6D3FBC7FB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389E00-071A-4E97-8741-1F820411485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7955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4DFBFC64-0858-75F7-64E6-DC1F107516F5}"/>
              </a:ext>
            </a:extLst>
          </p:cNvPr>
          <p:cNvSpPr/>
          <p:nvPr/>
        </p:nvSpPr>
        <p:spPr>
          <a:xfrm>
            <a:off x="3866017" y="1577892"/>
            <a:ext cx="2470025" cy="63398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5,064 participants attending the first follow up of CoLaus study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97EFA5DD-5B4A-51FA-3784-EFE97118CB43}"/>
              </a:ext>
            </a:extLst>
          </p:cNvPr>
          <p:cNvSpPr/>
          <p:nvPr/>
        </p:nvSpPr>
        <p:spPr>
          <a:xfrm>
            <a:off x="3866017" y="2593353"/>
            <a:ext cx="2470025" cy="63398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69" dirty="0"/>
              <a:t>2,582 participants </a:t>
            </a: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DDC4CC3F-ED37-AB5A-4544-C3F97D3F051B}"/>
              </a:ext>
            </a:extLst>
          </p:cNvPr>
          <p:cNvSpPr/>
          <p:nvPr/>
        </p:nvSpPr>
        <p:spPr>
          <a:xfrm>
            <a:off x="3866017" y="3608814"/>
            <a:ext cx="2470025" cy="63398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69" dirty="0"/>
              <a:t>2,577 participants </a:t>
            </a:r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8C88E10B-23DF-CE45-219D-DAAC74789656}"/>
              </a:ext>
            </a:extLst>
          </p:cNvPr>
          <p:cNvSpPr/>
          <p:nvPr/>
        </p:nvSpPr>
        <p:spPr>
          <a:xfrm>
            <a:off x="3866017" y="4624275"/>
            <a:ext cx="2470025" cy="63398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69" dirty="0"/>
              <a:t>2,233 participants </a:t>
            </a:r>
          </a:p>
        </p:txBody>
      </p:sp>
      <p:sp>
        <p:nvSpPr>
          <p:cNvPr id="8" name="Hexagon 7">
            <a:extLst>
              <a:ext uri="{FF2B5EF4-FFF2-40B4-BE49-F238E27FC236}">
                <a16:creationId xmlns:a16="http://schemas.microsoft.com/office/drawing/2014/main" id="{E210971F-3C36-107E-28B4-F691D7566B66}"/>
              </a:ext>
            </a:extLst>
          </p:cNvPr>
          <p:cNvSpPr/>
          <p:nvPr/>
        </p:nvSpPr>
        <p:spPr>
          <a:xfrm>
            <a:off x="6336043" y="2116768"/>
            <a:ext cx="2046264" cy="525220"/>
          </a:xfrm>
          <a:prstGeom prst="hexag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482 participants not eligible</a:t>
            </a:r>
            <a:endParaRPr lang="en-GB" sz="969" dirty="0"/>
          </a:p>
        </p:txBody>
      </p:sp>
      <p:sp>
        <p:nvSpPr>
          <p:cNvPr id="9" name="Hexagon 8">
            <a:extLst>
              <a:ext uri="{FF2B5EF4-FFF2-40B4-BE49-F238E27FC236}">
                <a16:creationId xmlns:a16="http://schemas.microsoft.com/office/drawing/2014/main" id="{71EF4E9D-DB75-1428-BECF-BA096CC7E946}"/>
              </a:ext>
            </a:extLst>
          </p:cNvPr>
          <p:cNvSpPr/>
          <p:nvPr/>
        </p:nvSpPr>
        <p:spPr>
          <a:xfrm>
            <a:off x="6336122" y="3166250"/>
            <a:ext cx="2046185" cy="525877"/>
          </a:xfrm>
          <a:prstGeom prst="hexag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participants excluded due to missing anthropometry data</a:t>
            </a:r>
          </a:p>
        </p:txBody>
      </p:sp>
      <p:sp>
        <p:nvSpPr>
          <p:cNvPr id="10" name="Hexagon 9">
            <a:extLst>
              <a:ext uri="{FF2B5EF4-FFF2-40B4-BE49-F238E27FC236}">
                <a16:creationId xmlns:a16="http://schemas.microsoft.com/office/drawing/2014/main" id="{F0D451F8-C83C-9EAC-9CA9-39FBCD79E56A}"/>
              </a:ext>
            </a:extLst>
          </p:cNvPr>
          <p:cNvSpPr/>
          <p:nvPr/>
        </p:nvSpPr>
        <p:spPr>
          <a:xfrm>
            <a:off x="6372974" y="4158065"/>
            <a:ext cx="2046185" cy="525877"/>
          </a:xfrm>
          <a:prstGeom prst="hexag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4 participants excluded due to missing other covariate data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768A355E-4BBE-B0BA-8471-2ADE686288EF}"/>
              </a:ext>
            </a:extLst>
          </p:cNvPr>
          <p:cNvCxnSpPr>
            <a:stCxn id="4" idx="2"/>
            <a:endCxn id="5" idx="0"/>
          </p:cNvCxnSpPr>
          <p:nvPr/>
        </p:nvCxnSpPr>
        <p:spPr>
          <a:xfrm>
            <a:off x="5101029" y="2211879"/>
            <a:ext cx="0" cy="38147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996524B-59AA-5EF0-A4C3-4D6F5B237C0A}"/>
              </a:ext>
            </a:extLst>
          </p:cNvPr>
          <p:cNvCxnSpPr>
            <a:cxnSpLocks/>
            <a:endCxn id="6" idx="0"/>
          </p:cNvCxnSpPr>
          <p:nvPr/>
        </p:nvCxnSpPr>
        <p:spPr>
          <a:xfrm flipH="1">
            <a:off x="5101029" y="3227340"/>
            <a:ext cx="1" cy="381474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5B419BF-649D-7BCE-C98A-76C55ACA7825}"/>
              </a:ext>
            </a:extLst>
          </p:cNvPr>
          <p:cNvCxnSpPr>
            <a:cxnSpLocks/>
            <a:endCxn id="7" idx="0"/>
          </p:cNvCxnSpPr>
          <p:nvPr/>
        </p:nvCxnSpPr>
        <p:spPr>
          <a:xfrm flipH="1">
            <a:off x="5101030" y="4216389"/>
            <a:ext cx="297" cy="40788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7C782AD0-53D7-9D31-8E77-078DCA7E6D7B}"/>
              </a:ext>
            </a:extLst>
          </p:cNvPr>
          <p:cNvCxnSpPr>
            <a:cxnSpLocks/>
            <a:endCxn id="8" idx="3"/>
          </p:cNvCxnSpPr>
          <p:nvPr/>
        </p:nvCxnSpPr>
        <p:spPr>
          <a:xfrm>
            <a:off x="5101030" y="2379377"/>
            <a:ext cx="1235014" cy="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F55BB86F-756A-D889-8D44-D73463F45247}"/>
              </a:ext>
            </a:extLst>
          </p:cNvPr>
          <p:cNvCxnSpPr>
            <a:cxnSpLocks/>
            <a:endCxn id="10" idx="3"/>
          </p:cNvCxnSpPr>
          <p:nvPr/>
        </p:nvCxnSpPr>
        <p:spPr>
          <a:xfrm>
            <a:off x="5101029" y="4421004"/>
            <a:ext cx="1271945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6FC4D730-3ADF-C822-0A85-62B4ECB20FC3}"/>
              </a:ext>
            </a:extLst>
          </p:cNvPr>
          <p:cNvSpPr txBox="1"/>
          <p:nvPr/>
        </p:nvSpPr>
        <p:spPr>
          <a:xfrm>
            <a:off x="3903811" y="610603"/>
            <a:ext cx="2611115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lection procedure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D6AD75B1-D861-09A6-9579-BC789AD20899}"/>
              </a:ext>
            </a:extLst>
          </p:cNvPr>
          <p:cNvCxnSpPr>
            <a:cxnSpLocks/>
            <a:endCxn id="9" idx="3"/>
          </p:cNvCxnSpPr>
          <p:nvPr/>
        </p:nvCxnSpPr>
        <p:spPr>
          <a:xfrm>
            <a:off x="5101030" y="3429188"/>
            <a:ext cx="12350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06423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1">
            <a:extLst>
              <a:ext uri="{FF2B5EF4-FFF2-40B4-BE49-F238E27FC236}">
                <a16:creationId xmlns:a16="http://schemas.microsoft.com/office/drawing/2014/main" id="{FF5AB879-9C63-E4AB-CE04-21C2028C581B}"/>
              </a:ext>
            </a:extLst>
          </p:cNvPr>
          <p:cNvSpPr txBox="1"/>
          <p:nvPr/>
        </p:nvSpPr>
        <p:spPr>
          <a:xfrm>
            <a:off x="3961021" y="156109"/>
            <a:ext cx="4508902" cy="838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6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pike graph showing the beta correlation coefficients between acylcarnitine species and anthropometry markers, stratified by sex. The X-axis indicate the absolute value of the beta correlation coefficients. Red colour indicates a negative association, black colour indicates a positive association.</a:t>
            </a:r>
            <a:b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1">
            <a:extLst>
              <a:ext uri="{FF2B5EF4-FFF2-40B4-BE49-F238E27FC236}">
                <a16:creationId xmlns:a16="http://schemas.microsoft.com/office/drawing/2014/main" id="{DCBF4669-582B-8A46-9B1D-892A918BFEC4}"/>
              </a:ext>
            </a:extLst>
          </p:cNvPr>
          <p:cNvSpPr txBox="1"/>
          <p:nvPr/>
        </p:nvSpPr>
        <p:spPr>
          <a:xfrm>
            <a:off x="4193172" y="1689173"/>
            <a:ext cx="195566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2">
            <a:extLst>
              <a:ext uri="{FF2B5EF4-FFF2-40B4-BE49-F238E27FC236}">
                <a16:creationId xmlns:a16="http://schemas.microsoft.com/office/drawing/2014/main" id="{AC69ECA5-2951-5ECA-031B-7E1116F6AD13}"/>
              </a:ext>
            </a:extLst>
          </p:cNvPr>
          <p:cNvSpPr txBox="1"/>
          <p:nvPr/>
        </p:nvSpPr>
        <p:spPr>
          <a:xfrm>
            <a:off x="4206992" y="3850400"/>
            <a:ext cx="199636" cy="390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 descr="A graph with red and black lines&#10;&#10;AI-generated content may be incorrect.">
            <a:extLst>
              <a:ext uri="{FF2B5EF4-FFF2-40B4-BE49-F238E27FC236}">
                <a16:creationId xmlns:a16="http://schemas.microsoft.com/office/drawing/2014/main" id="{0B7D7260-0EAA-9EE9-E793-0497C74216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9216" y="1034384"/>
            <a:ext cx="3156923" cy="1894154"/>
          </a:xfrm>
          <a:prstGeom prst="rect">
            <a:avLst/>
          </a:prstGeom>
        </p:spPr>
      </p:pic>
      <p:pic>
        <p:nvPicPr>
          <p:cNvPr id="12" name="Picture 11" descr="A graph with red and black lines&#10;&#10;AI-generated content may be incorrect.">
            <a:extLst>
              <a:ext uri="{FF2B5EF4-FFF2-40B4-BE49-F238E27FC236}">
                <a16:creationId xmlns:a16="http://schemas.microsoft.com/office/drawing/2014/main" id="{9DC008C7-5FF0-4353-A251-2DC146584D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9216" y="3203312"/>
            <a:ext cx="3156923" cy="189415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CC5838E-BEAC-2B9E-6971-B60043971B73}"/>
              </a:ext>
            </a:extLst>
          </p:cNvPr>
          <p:cNvSpPr txBox="1"/>
          <p:nvPr/>
        </p:nvSpPr>
        <p:spPr>
          <a:xfrm>
            <a:off x="3961021" y="6011627"/>
            <a:ext cx="4508902" cy="5397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Body Mass Index (BMI), Waist to Hip ratio (WHR), Waist to Height Ratio (</a:t>
            </a:r>
            <a:r>
              <a:rPr lang="en-GB" sz="969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tR</a:t>
            </a:r>
            <a: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Body Roundness Index (BRI), Body Shape Index (BSI), Bioelectrical Impedance Analysis (BIA)</a:t>
            </a:r>
          </a:p>
        </p:txBody>
      </p:sp>
    </p:spTree>
    <p:extLst>
      <p:ext uri="{BB962C8B-B14F-4D97-AF65-F5344CB8AC3E}">
        <p14:creationId xmlns:p14="http://schemas.microsoft.com/office/powerpoint/2010/main" val="3553233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1">
            <a:extLst>
              <a:ext uri="{FF2B5EF4-FFF2-40B4-BE49-F238E27FC236}">
                <a16:creationId xmlns:a16="http://schemas.microsoft.com/office/drawing/2014/main" id="{1155187C-4B7B-D6EE-DB52-198FC4B468D2}"/>
              </a:ext>
            </a:extLst>
          </p:cNvPr>
          <p:cNvSpPr txBox="1"/>
          <p:nvPr/>
        </p:nvSpPr>
        <p:spPr>
          <a:xfrm>
            <a:off x="4316880" y="629748"/>
            <a:ext cx="293351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2">
            <a:extLst>
              <a:ext uri="{FF2B5EF4-FFF2-40B4-BE49-F238E27FC236}">
                <a16:creationId xmlns:a16="http://schemas.microsoft.com/office/drawing/2014/main" id="{0DF4E9FD-D3FE-EB01-3EA3-5B58453CED2D}"/>
              </a:ext>
            </a:extLst>
          </p:cNvPr>
          <p:cNvSpPr txBox="1"/>
          <p:nvPr/>
        </p:nvSpPr>
        <p:spPr>
          <a:xfrm>
            <a:off x="4316880" y="2368944"/>
            <a:ext cx="293350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iv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1">
            <a:extLst>
              <a:ext uri="{FF2B5EF4-FFF2-40B4-BE49-F238E27FC236}">
                <a16:creationId xmlns:a16="http://schemas.microsoft.com/office/drawing/2014/main" id="{45DF9DC6-89C9-8AB3-6DE4-C0B7C366918B}"/>
              </a:ext>
            </a:extLst>
          </p:cNvPr>
          <p:cNvSpPr txBox="1"/>
          <p:nvPr/>
        </p:nvSpPr>
        <p:spPr>
          <a:xfrm>
            <a:off x="4316880" y="4034832"/>
            <a:ext cx="293351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2">
            <a:extLst>
              <a:ext uri="{FF2B5EF4-FFF2-40B4-BE49-F238E27FC236}">
                <a16:creationId xmlns:a16="http://schemas.microsoft.com/office/drawing/2014/main" id="{0D90952E-8E99-79A4-1255-3F656299292D}"/>
              </a:ext>
            </a:extLst>
          </p:cNvPr>
          <p:cNvSpPr txBox="1"/>
          <p:nvPr/>
        </p:nvSpPr>
        <p:spPr>
          <a:xfrm>
            <a:off x="4316880" y="5774028"/>
            <a:ext cx="293350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8" descr="A graph of a person and person&#10;&#10;AI-generated content may be incorrect.">
            <a:extLst>
              <a:ext uri="{FF2B5EF4-FFF2-40B4-BE49-F238E27FC236}">
                <a16:creationId xmlns:a16="http://schemas.microsoft.com/office/drawing/2014/main" id="{6AD7B97C-B059-AEF8-ECCE-1BA0B51B43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8197" y="-21795"/>
            <a:ext cx="3156923" cy="1894154"/>
          </a:xfrm>
          <a:prstGeom prst="rect">
            <a:avLst/>
          </a:prstGeom>
        </p:spPr>
      </p:pic>
      <p:pic>
        <p:nvPicPr>
          <p:cNvPr id="21" name="Picture 20" descr="A graph with black and red lines&#10;&#10;AI-generated content may be incorrect.">
            <a:extLst>
              <a:ext uri="{FF2B5EF4-FFF2-40B4-BE49-F238E27FC236}">
                <a16:creationId xmlns:a16="http://schemas.microsoft.com/office/drawing/2014/main" id="{76B911FB-84A1-DEBD-D8CF-C3EFC23C66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8197" y="1654591"/>
            <a:ext cx="3156923" cy="1894154"/>
          </a:xfrm>
          <a:prstGeom prst="rect">
            <a:avLst/>
          </a:prstGeom>
        </p:spPr>
      </p:pic>
      <p:pic>
        <p:nvPicPr>
          <p:cNvPr id="23" name="Picture 22" descr="A graph with black and red lines&#10;&#10;AI-generated content may be incorrect.">
            <a:extLst>
              <a:ext uri="{FF2B5EF4-FFF2-40B4-BE49-F238E27FC236}">
                <a16:creationId xmlns:a16="http://schemas.microsoft.com/office/drawing/2014/main" id="{15B943EF-9EA0-06B5-E584-CE86C13845B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8197" y="3333490"/>
            <a:ext cx="3156923" cy="1894154"/>
          </a:xfrm>
          <a:prstGeom prst="rect">
            <a:avLst/>
          </a:prstGeom>
        </p:spPr>
      </p:pic>
      <p:pic>
        <p:nvPicPr>
          <p:cNvPr id="25" name="Picture 24" descr="A graph with red and black lines&#10;&#10;AI-generated content may be incorrect.">
            <a:extLst>
              <a:ext uri="{FF2B5EF4-FFF2-40B4-BE49-F238E27FC236}">
                <a16:creationId xmlns:a16="http://schemas.microsoft.com/office/drawing/2014/main" id="{74AE6C31-5A42-821F-4A82-EC318AC88DD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8197" y="5009876"/>
            <a:ext cx="3156923" cy="1894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16926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1">
            <a:extLst>
              <a:ext uri="{FF2B5EF4-FFF2-40B4-BE49-F238E27FC236}">
                <a16:creationId xmlns:a16="http://schemas.microsoft.com/office/drawing/2014/main" id="{88F99114-4734-B53F-A26A-D5FCFA041D97}"/>
              </a:ext>
            </a:extLst>
          </p:cNvPr>
          <p:cNvSpPr txBox="1"/>
          <p:nvPr/>
        </p:nvSpPr>
        <p:spPr>
          <a:xfrm>
            <a:off x="4316880" y="649844"/>
            <a:ext cx="293351" cy="390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i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9CFBCD8-6398-2B12-EDFE-E50AF9552FEF}"/>
              </a:ext>
            </a:extLst>
          </p:cNvPr>
          <p:cNvSpPr txBox="1"/>
          <p:nvPr/>
        </p:nvSpPr>
        <p:spPr>
          <a:xfrm>
            <a:off x="4316880" y="2389040"/>
            <a:ext cx="293350" cy="390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ii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1">
            <a:extLst>
              <a:ext uri="{FF2B5EF4-FFF2-40B4-BE49-F238E27FC236}">
                <a16:creationId xmlns:a16="http://schemas.microsoft.com/office/drawing/2014/main" id="{B08A4C3F-ED2D-7BDC-13BF-2DFADAE7DAAC}"/>
              </a:ext>
            </a:extLst>
          </p:cNvPr>
          <p:cNvSpPr txBox="1"/>
          <p:nvPr/>
        </p:nvSpPr>
        <p:spPr>
          <a:xfrm>
            <a:off x="4316880" y="4054928"/>
            <a:ext cx="293351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ix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2">
            <a:extLst>
              <a:ext uri="{FF2B5EF4-FFF2-40B4-BE49-F238E27FC236}">
                <a16:creationId xmlns:a16="http://schemas.microsoft.com/office/drawing/2014/main" id="{6CF6B515-1097-9D63-3440-CCB6B50A2C91}"/>
              </a:ext>
            </a:extLst>
          </p:cNvPr>
          <p:cNvSpPr txBox="1"/>
          <p:nvPr/>
        </p:nvSpPr>
        <p:spPr>
          <a:xfrm>
            <a:off x="4316880" y="5794124"/>
            <a:ext cx="293350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8" descr="A graph of a person and person&#10;&#10;AI-generated content may be incorrect.">
            <a:extLst>
              <a:ext uri="{FF2B5EF4-FFF2-40B4-BE49-F238E27FC236}">
                <a16:creationId xmlns:a16="http://schemas.microsoft.com/office/drawing/2014/main" id="{0F7A7A1E-EB5E-5EDF-D437-0ED04847C0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0230" y="-10048"/>
            <a:ext cx="3156923" cy="1894154"/>
          </a:xfrm>
          <a:prstGeom prst="rect">
            <a:avLst/>
          </a:prstGeom>
        </p:spPr>
      </p:pic>
      <p:pic>
        <p:nvPicPr>
          <p:cNvPr id="21" name="Picture 20" descr="A graph with red and black lines&#10;&#10;AI-generated content may be incorrect.">
            <a:extLst>
              <a:ext uri="{FF2B5EF4-FFF2-40B4-BE49-F238E27FC236}">
                <a16:creationId xmlns:a16="http://schemas.microsoft.com/office/drawing/2014/main" id="{8F67E7F0-6355-114A-4615-7DFD566125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0230" y="1656472"/>
            <a:ext cx="3156923" cy="1894154"/>
          </a:xfrm>
          <a:prstGeom prst="rect">
            <a:avLst/>
          </a:prstGeom>
        </p:spPr>
      </p:pic>
      <p:pic>
        <p:nvPicPr>
          <p:cNvPr id="23" name="Picture 22" descr="A graph with red and black lines&#10;&#10;AI-generated content may be incorrect.">
            <a:extLst>
              <a:ext uri="{FF2B5EF4-FFF2-40B4-BE49-F238E27FC236}">
                <a16:creationId xmlns:a16="http://schemas.microsoft.com/office/drawing/2014/main" id="{61825C71-5758-ACA4-D1B1-6722931E37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0230" y="3310880"/>
            <a:ext cx="3156923" cy="1894154"/>
          </a:xfrm>
          <a:prstGeom prst="rect">
            <a:avLst/>
          </a:prstGeom>
        </p:spPr>
      </p:pic>
      <p:pic>
        <p:nvPicPr>
          <p:cNvPr id="25" name="Picture 24" descr="A graph with black and red lines&#10;&#10;AI-generated content may be incorrect.">
            <a:extLst>
              <a:ext uri="{FF2B5EF4-FFF2-40B4-BE49-F238E27FC236}">
                <a16:creationId xmlns:a16="http://schemas.microsoft.com/office/drawing/2014/main" id="{D2DE2933-B5AA-B32F-D4A6-2E41D4683DF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0230" y="4976768"/>
            <a:ext cx="3156923" cy="1894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03257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1">
            <a:extLst>
              <a:ext uri="{FF2B5EF4-FFF2-40B4-BE49-F238E27FC236}">
                <a16:creationId xmlns:a16="http://schemas.microsoft.com/office/drawing/2014/main" id="{CCF3A650-4DF1-FF35-0B8C-BDB6F033E6A8}"/>
              </a:ext>
            </a:extLst>
          </p:cNvPr>
          <p:cNvSpPr txBox="1"/>
          <p:nvPr/>
        </p:nvSpPr>
        <p:spPr>
          <a:xfrm>
            <a:off x="4280851" y="1263993"/>
            <a:ext cx="293351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A7573C2-0AF2-251D-AD7B-C9D3E4F3F011}"/>
              </a:ext>
            </a:extLst>
          </p:cNvPr>
          <p:cNvSpPr txBox="1"/>
          <p:nvPr/>
        </p:nvSpPr>
        <p:spPr>
          <a:xfrm>
            <a:off x="4280851" y="3003189"/>
            <a:ext cx="293350" cy="390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i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11">
            <a:extLst>
              <a:ext uri="{FF2B5EF4-FFF2-40B4-BE49-F238E27FC236}">
                <a16:creationId xmlns:a16="http://schemas.microsoft.com/office/drawing/2014/main" id="{164761CF-9DED-D554-24A1-8D6AB689AF37}"/>
              </a:ext>
            </a:extLst>
          </p:cNvPr>
          <p:cNvSpPr txBox="1"/>
          <p:nvPr/>
        </p:nvSpPr>
        <p:spPr>
          <a:xfrm>
            <a:off x="4280851" y="4669077"/>
            <a:ext cx="293351" cy="390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ii</a:t>
            </a:r>
            <a:endParaRPr lang="en-GB" sz="9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Picture 11" descr="A graph with red and black lines&#10;&#10;AI-generated content may be incorrect.">
            <a:extLst>
              <a:ext uri="{FF2B5EF4-FFF2-40B4-BE49-F238E27FC236}">
                <a16:creationId xmlns:a16="http://schemas.microsoft.com/office/drawing/2014/main" id="{50D3E9CC-65B0-C70B-53DD-E170A353AA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4201" y="311666"/>
            <a:ext cx="3156923" cy="1894154"/>
          </a:xfrm>
          <a:prstGeom prst="rect">
            <a:avLst/>
          </a:prstGeom>
        </p:spPr>
      </p:pic>
      <p:pic>
        <p:nvPicPr>
          <p:cNvPr id="14" name="Picture 13" descr="A graph of a number of men and women&#10;&#10;AI-generated content may be incorrect.">
            <a:extLst>
              <a:ext uri="{FF2B5EF4-FFF2-40B4-BE49-F238E27FC236}">
                <a16:creationId xmlns:a16="http://schemas.microsoft.com/office/drawing/2014/main" id="{B6619D58-8FBD-99E8-2D2C-57B7FDFBDD1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4201" y="2056112"/>
            <a:ext cx="3156923" cy="1894154"/>
          </a:xfrm>
          <a:prstGeom prst="rect">
            <a:avLst/>
          </a:prstGeom>
        </p:spPr>
      </p:pic>
      <p:pic>
        <p:nvPicPr>
          <p:cNvPr id="16" name="Picture 15" descr="A graph with black and red lines&#10;&#10;AI-generated content may be incorrect.">
            <a:extLst>
              <a:ext uri="{FF2B5EF4-FFF2-40B4-BE49-F238E27FC236}">
                <a16:creationId xmlns:a16="http://schemas.microsoft.com/office/drawing/2014/main" id="{2DE38FA2-8069-0CDA-7BAC-4CE685BC223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4201" y="3795308"/>
            <a:ext cx="3156923" cy="1894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26920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1">
            <a:extLst>
              <a:ext uri="{FF2B5EF4-FFF2-40B4-BE49-F238E27FC236}">
                <a16:creationId xmlns:a16="http://schemas.microsoft.com/office/drawing/2014/main" id="{641090A6-0DFE-291C-C4EB-44CD813DB15A}"/>
              </a:ext>
            </a:extLst>
          </p:cNvPr>
          <p:cNvSpPr txBox="1"/>
          <p:nvPr/>
        </p:nvSpPr>
        <p:spPr>
          <a:xfrm>
            <a:off x="0" y="409028"/>
            <a:ext cx="12192000" cy="2414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6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GB" sz="9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eta coefficients representing the associations between anthropometric markers and acylcarnitine species.</a:t>
            </a:r>
          </a:p>
        </p:txBody>
      </p:sp>
      <p:pic>
        <p:nvPicPr>
          <p:cNvPr id="9" name="Picture 8" descr="A colorful squares with white text&#10;&#10;AI-generated content may be incorrect.">
            <a:extLst>
              <a:ext uri="{FF2B5EF4-FFF2-40B4-BE49-F238E27FC236}">
                <a16:creationId xmlns:a16="http://schemas.microsoft.com/office/drawing/2014/main" id="{0514733C-1C9F-813A-817C-87384C7941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5171" y="764502"/>
            <a:ext cx="8881658" cy="53289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4273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3</Words>
  <Application>Microsoft Office PowerPoint</Application>
  <PresentationFormat>Widescreen</PresentationFormat>
  <Paragraphs>26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 Ko Maung Ko Ko Maung</dc:creator>
  <cp:lastModifiedBy>MDPI</cp:lastModifiedBy>
  <cp:revision>8</cp:revision>
  <dcterms:created xsi:type="dcterms:W3CDTF">2025-10-24T08:58:45Z</dcterms:created>
  <dcterms:modified xsi:type="dcterms:W3CDTF">2026-05-06T10:30:50Z</dcterms:modified>
</cp:coreProperties>
</file>